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77075" cy="9051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7" d="100"/>
          <a:sy n="77" d="100"/>
        </p:scale>
        <p:origin x="-306" y="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74981981422449"/>
          <c:y val="2.364020402704373E-2"/>
          <c:w val="0.88474783379866284"/>
          <c:h val="0.881836645419322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PB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285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5"/>
                <c:pt idx="0">
                  <c:v>1.1900000000000001E-3</c:v>
                </c:pt>
                <c:pt idx="1">
                  <c:v>1.97E-3</c:v>
                </c:pt>
                <c:pt idx="2">
                  <c:v>1.47E-3</c:v>
                </c:pt>
                <c:pt idx="3">
                  <c:v>1.34E-3</c:v>
                </c:pt>
                <c:pt idx="4">
                  <c:v>1.3500000000000001E-3</c:v>
                </c:pt>
              </c:numLit>
            </c:plus>
            <c:minus>
              <c:numLit>
                <c:formatCode>General</c:formatCode>
                <c:ptCount val="5"/>
                <c:pt idx="0">
                  <c:v>1.1900000000000001E-3</c:v>
                </c:pt>
                <c:pt idx="1">
                  <c:v>1.97E-3</c:v>
                </c:pt>
                <c:pt idx="2">
                  <c:v>1.47E-3</c:v>
                </c:pt>
                <c:pt idx="3">
                  <c:v>1.34E-3</c:v>
                </c:pt>
                <c:pt idx="4">
                  <c:v>1.3500000000000001E-3</c:v>
                </c:pt>
              </c:numLit>
            </c:minus>
            <c:spPr>
              <a:ln w="28575">
                <a:solidFill>
                  <a:schemeClr val="tx1"/>
                </a:solidFill>
              </a:ln>
            </c:spPr>
          </c:errBars>
          <c:cat>
            <c:strRef>
              <c:f>Sheet1!$B$1:$F$1</c:f>
              <c:strCache>
                <c:ptCount val="5"/>
                <c:pt idx="0">
                  <c:v>10 µl</c:v>
                </c:pt>
                <c:pt idx="1">
                  <c:v>20 µl</c:v>
                </c:pt>
                <c:pt idx="2">
                  <c:v>40 µl</c:v>
                </c:pt>
                <c:pt idx="3">
                  <c:v>80 µl</c:v>
                </c:pt>
                <c:pt idx="4">
                  <c:v>100 µl</c:v>
                </c:pt>
              </c:strCache>
            </c:strRef>
          </c:cat>
          <c:val>
            <c:numRef>
              <c:f>Sheet1!$B$2:$F$2</c:f>
              <c:numCache>
                <c:formatCode>General</c:formatCode>
                <c:ptCount val="5"/>
                <c:pt idx="0">
                  <c:v>0.12501999999999999</c:v>
                </c:pt>
                <c:pt idx="1">
                  <c:v>0.12211</c:v>
                </c:pt>
                <c:pt idx="2">
                  <c:v>0.12333</c:v>
                </c:pt>
                <c:pt idx="3">
                  <c:v>0.12358</c:v>
                </c:pt>
                <c:pt idx="4">
                  <c:v>0.12398000000000001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TIM207</c:v>
                </c:pt>
              </c:strCache>
            </c:strRef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 w="285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5"/>
                <c:pt idx="0">
                  <c:v>3.2499999999999999E-3</c:v>
                </c:pt>
                <c:pt idx="1">
                  <c:v>5.9199999999999999E-3</c:v>
                </c:pt>
                <c:pt idx="2">
                  <c:v>7.5500000000000003E-3</c:v>
                </c:pt>
                <c:pt idx="3">
                  <c:v>9.9180000000000004E-2</c:v>
                </c:pt>
                <c:pt idx="4">
                  <c:v>7.399E-2</c:v>
                </c:pt>
              </c:numLit>
            </c:plus>
            <c:minus>
              <c:numLit>
                <c:formatCode>General</c:formatCode>
                <c:ptCount val="5"/>
                <c:pt idx="0">
                  <c:v>3.2499999999999999E-3</c:v>
                </c:pt>
                <c:pt idx="1">
                  <c:v>5.9199999999999999E-3</c:v>
                </c:pt>
                <c:pt idx="2">
                  <c:v>7.5500000000000003E-3</c:v>
                </c:pt>
                <c:pt idx="3">
                  <c:v>9.9180000000000004E-2</c:v>
                </c:pt>
                <c:pt idx="4">
                  <c:v>7.399E-2</c:v>
                </c:pt>
              </c:numLit>
            </c:minus>
            <c:spPr>
              <a:ln w="28575">
                <a:solidFill>
                  <a:schemeClr val="tx1"/>
                </a:solidFill>
              </a:ln>
            </c:spPr>
          </c:errBars>
          <c:cat>
            <c:strRef>
              <c:f>Sheet1!$B$1:$F$1</c:f>
              <c:strCache>
                <c:ptCount val="5"/>
                <c:pt idx="0">
                  <c:v>10 µl</c:v>
                </c:pt>
                <c:pt idx="1">
                  <c:v>20 µl</c:v>
                </c:pt>
                <c:pt idx="2">
                  <c:v>40 µl</c:v>
                </c:pt>
                <c:pt idx="3">
                  <c:v>80 µl</c:v>
                </c:pt>
                <c:pt idx="4">
                  <c:v>100 µl</c:v>
                </c:pt>
              </c:strCache>
            </c:strRef>
          </c:cat>
          <c:val>
            <c:numRef>
              <c:f>Sheet1!$B$3:$F$3</c:f>
              <c:numCache>
                <c:formatCode>General</c:formatCode>
                <c:ptCount val="5"/>
                <c:pt idx="0">
                  <c:v>0.18657000000000001</c:v>
                </c:pt>
                <c:pt idx="1">
                  <c:v>0.24857000000000001</c:v>
                </c:pt>
                <c:pt idx="2">
                  <c:v>0.37724999999999997</c:v>
                </c:pt>
                <c:pt idx="3">
                  <c:v>0.66773000000000005</c:v>
                </c:pt>
                <c:pt idx="4">
                  <c:v>0.83109</c:v>
                </c:pt>
              </c:numCache>
            </c:numRef>
          </c:val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G37</c:v>
                </c:pt>
              </c:strCache>
            </c:strRef>
          </c:tx>
          <c:spPr>
            <a:solidFill>
              <a:schemeClr val="tx1"/>
            </a:solidFill>
            <a:ln w="28575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5"/>
                <c:pt idx="0">
                  <c:v>2.6900000000000001E-3</c:v>
                </c:pt>
                <c:pt idx="1">
                  <c:v>8.8199999999999997E-3</c:v>
                </c:pt>
                <c:pt idx="2">
                  <c:v>9.5200000000000007E-3</c:v>
                </c:pt>
                <c:pt idx="3">
                  <c:v>3.3360000000000001E-2</c:v>
                </c:pt>
                <c:pt idx="4">
                  <c:v>5.0160000000000003E-2</c:v>
                </c:pt>
              </c:numLit>
            </c:plus>
            <c:minus>
              <c:numLit>
                <c:formatCode>General</c:formatCode>
                <c:ptCount val="5"/>
                <c:pt idx="0">
                  <c:v>2.6900000000000001E-3</c:v>
                </c:pt>
                <c:pt idx="1">
                  <c:v>8.8199999999999997E-3</c:v>
                </c:pt>
                <c:pt idx="2">
                  <c:v>9.5200000000000007E-3</c:v>
                </c:pt>
                <c:pt idx="3">
                  <c:v>3.3360000000000001E-2</c:v>
                </c:pt>
                <c:pt idx="4">
                  <c:v>5.0160000000000003E-2</c:v>
                </c:pt>
              </c:numLit>
            </c:minus>
            <c:spPr>
              <a:ln w="28575">
                <a:solidFill>
                  <a:schemeClr val="tx1"/>
                </a:solidFill>
              </a:ln>
            </c:spPr>
          </c:errBars>
          <c:cat>
            <c:strRef>
              <c:f>Sheet1!$B$1:$F$1</c:f>
              <c:strCache>
                <c:ptCount val="5"/>
                <c:pt idx="0">
                  <c:v>10 µl</c:v>
                </c:pt>
                <c:pt idx="1">
                  <c:v>20 µl</c:v>
                </c:pt>
                <c:pt idx="2">
                  <c:v>40 µl</c:v>
                </c:pt>
                <c:pt idx="3">
                  <c:v>80 µl</c:v>
                </c:pt>
                <c:pt idx="4">
                  <c:v>100 µl</c:v>
                </c:pt>
              </c:strCache>
            </c:strRef>
          </c:cat>
          <c:val>
            <c:numRef>
              <c:f>Sheet1!$B$4:$F$4</c:f>
              <c:numCache>
                <c:formatCode>General</c:formatCode>
                <c:ptCount val="5"/>
                <c:pt idx="0">
                  <c:v>0.17693999999999999</c:v>
                </c:pt>
                <c:pt idx="1">
                  <c:v>0.23114000000000001</c:v>
                </c:pt>
                <c:pt idx="2">
                  <c:v>0.34750999999999999</c:v>
                </c:pt>
                <c:pt idx="3">
                  <c:v>0.65032000000000001</c:v>
                </c:pt>
                <c:pt idx="4">
                  <c:v>0.77388000000000001</c:v>
                </c:pt>
              </c:numCache>
            </c:numRef>
          </c:val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TIM262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 w="285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5"/>
                <c:pt idx="0">
                  <c:v>1.6100000000000001E-3</c:v>
                </c:pt>
                <c:pt idx="1">
                  <c:v>3.0100000000000001E-3</c:v>
                </c:pt>
                <c:pt idx="2">
                  <c:v>1.277E-2</c:v>
                </c:pt>
                <c:pt idx="3">
                  <c:v>2.2769999999999999E-2</c:v>
                </c:pt>
                <c:pt idx="4">
                  <c:v>4.6300000000000001E-2</c:v>
                </c:pt>
              </c:numLit>
            </c:plus>
            <c:minus>
              <c:numLit>
                <c:formatCode>General</c:formatCode>
                <c:ptCount val="5"/>
                <c:pt idx="0">
                  <c:v>1.6100000000000001E-3</c:v>
                </c:pt>
                <c:pt idx="1">
                  <c:v>3.0100000000000001E-3</c:v>
                </c:pt>
                <c:pt idx="2">
                  <c:v>1.277E-2</c:v>
                </c:pt>
                <c:pt idx="3">
                  <c:v>2.2769999999999999E-2</c:v>
                </c:pt>
                <c:pt idx="4">
                  <c:v>4.6300000000000001E-2</c:v>
                </c:pt>
              </c:numLit>
            </c:minus>
            <c:spPr>
              <a:ln w="28575">
                <a:solidFill>
                  <a:schemeClr val="tx1"/>
                </a:solidFill>
              </a:ln>
            </c:spPr>
          </c:errBars>
          <c:cat>
            <c:strRef>
              <c:f>Sheet1!$B$1:$F$1</c:f>
              <c:strCache>
                <c:ptCount val="5"/>
                <c:pt idx="0">
                  <c:v>10 µl</c:v>
                </c:pt>
                <c:pt idx="1">
                  <c:v>20 µl</c:v>
                </c:pt>
                <c:pt idx="2">
                  <c:v>40 µl</c:v>
                </c:pt>
                <c:pt idx="3">
                  <c:v>80 µl</c:v>
                </c:pt>
                <c:pt idx="4">
                  <c:v>100 µl</c:v>
                </c:pt>
              </c:strCache>
            </c:strRef>
          </c:cat>
          <c:val>
            <c:numRef>
              <c:f>Sheet1!$B$5:$F$5</c:f>
              <c:numCache>
                <c:formatCode>General</c:formatCode>
                <c:ptCount val="5"/>
                <c:pt idx="0">
                  <c:v>0.17191000000000001</c:v>
                </c:pt>
                <c:pt idx="1">
                  <c:v>0.24961</c:v>
                </c:pt>
                <c:pt idx="2">
                  <c:v>0.31891999999999998</c:v>
                </c:pt>
                <c:pt idx="3">
                  <c:v>0.64</c:v>
                </c:pt>
                <c:pt idx="4">
                  <c:v>0.779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448384"/>
        <c:axId val="146451072"/>
      </c:barChart>
      <c:catAx>
        <c:axId val="14644838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46451072"/>
        <c:crosses val="autoZero"/>
        <c:auto val="1"/>
        <c:lblAlgn val="ctr"/>
        <c:lblOffset val="100"/>
        <c:noMultiLvlLbl val="0"/>
      </c:catAx>
      <c:valAx>
        <c:axId val="146451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 baseline="0" dirty="0" smtClean="0"/>
                  <a:t>OD 600 nm </a:t>
                </a:r>
                <a:endParaRPr lang="en-US" sz="1600" dirty="0"/>
              </a:p>
            </c:rich>
          </c:tx>
          <c:layout>
            <c:manualLayout>
              <c:xMode val="edge"/>
              <c:yMode val="edge"/>
              <c:x val="4.7428106812735368E-3"/>
              <c:y val="0.341204016164646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en-US"/>
          </a:p>
        </c:txPr>
        <c:crossAx val="1464483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5243716607856531"/>
          <c:y val="6.6082765124329396E-2"/>
          <c:w val="0.19617327299697693"/>
          <c:h val="0.2360301102819745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031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6994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423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5199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6022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092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7432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6219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3689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4845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4555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E41120-2326-4355-8752-D37106941320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C801A-9A35-4188-9B46-18051AAED20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8638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33400" y="5029200"/>
            <a:ext cx="8229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1: Viability of 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M. 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genitalium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trains based on color change assay.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M.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genitalium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37, TIM207 and TIM 262 were grown and harvested as described in method section. The bacteria wer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resuspend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n appropriate amount of PBS to give an OD</a:t>
            </a:r>
            <a:r>
              <a:rPr lang="en-US" sz="1200" baseline="-25000" dirty="0" smtClean="0">
                <a:latin typeface="Arial" pitchFamily="34" charset="0"/>
                <a:cs typeface="Arial" pitchFamily="34" charset="0"/>
              </a:rPr>
              <a:t>600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=1.0. Different volume of the inoculum, as indicated in the x-axis were added to 200 µl of SP-4 medium in a 96 well plate and incubated at 37°C for 6 h. Color change of SP-4 medium, due to the growth of mycoplasma, from red to orange was monitored by reading the plate at 620 nm in a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icroplat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ader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lid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grey bars, dotted bars, solid black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bars and horizontal stripped bars indicate absorbance (A</a:t>
            </a:r>
            <a:r>
              <a:rPr lang="en-US" sz="1200" baseline="-25000" dirty="0" smtClean="0">
                <a:latin typeface="Arial" pitchFamily="34" charset="0"/>
                <a:cs typeface="Arial" pitchFamily="34" charset="0"/>
              </a:rPr>
              <a:t>620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of PBS,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IM207, G37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nd TIM 262 respectively. The results indicate that there is no significant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difference in viability between th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trains at the time of harvest.</a:t>
            </a:r>
          </a:p>
        </p:txBody>
      </p:sp>
      <p:graphicFrame>
        <p:nvGraphicFramePr>
          <p:cNvPr id="5" name="Char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5333076"/>
              </p:ext>
            </p:extLst>
          </p:nvPr>
        </p:nvGraphicFramePr>
        <p:xfrm>
          <a:off x="533400" y="152400"/>
          <a:ext cx="7010400" cy="48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99614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16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ILAB</dc:creator>
  <cp:lastModifiedBy> </cp:lastModifiedBy>
  <cp:revision>29</cp:revision>
  <cp:lastPrinted>2013-02-07T17:55:04Z</cp:lastPrinted>
  <dcterms:created xsi:type="dcterms:W3CDTF">2013-01-29T17:21:00Z</dcterms:created>
  <dcterms:modified xsi:type="dcterms:W3CDTF">2013-02-09T01:14:50Z</dcterms:modified>
</cp:coreProperties>
</file>